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95" autoAdjust="0"/>
    <p:restoredTop sz="89599" autoAdjust="0"/>
  </p:normalViewPr>
  <p:slideViewPr>
    <p:cSldViewPr snapToGrid="0">
      <p:cViewPr varScale="1">
        <p:scale>
          <a:sx n="102" d="100"/>
          <a:sy n="102" d="100"/>
        </p:scale>
        <p:origin x="98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D76FCF-0FAD-483A-96FC-F77C3924D63E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71D681-A64E-4E83-8DF1-4ECE224AD29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049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wo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ETR1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348649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 for the protein SlCTR3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40173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wo selected heavy </a:t>
            </a:r>
            <a:r>
              <a:rPr lang="en-GB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EIN2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75708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 for the protein SlETR2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630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hree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ETR3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29184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hree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ETR4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396053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 for the protein SlETR5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383707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wo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ETR6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850327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wo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ETR7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711347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wo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CTR1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686751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ilution curves for the PRM analysis of 0–200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fmo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L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the two selected heavy </a:t>
            </a:r>
            <a:r>
              <a:rPr lang="en-GB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labeled</a:t>
            </a:r>
            <a:r>
              <a:rPr lang="en-GB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 for the protein SlCTR2 and linearity expressed by coefficient of determination (R2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71D681-A64E-4E83-8DF1-4ECE224AD295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2298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BE50B2-8506-4A29-B3C5-C69A57D0F5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77C48F-9898-498F-B7EC-AE5646A562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13F7CA-CD2C-461A-92C3-FEB5DA3C3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FA6914-B382-4EC3-B584-2A42F8B72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CFE791-1944-4B2B-B8C0-DE3765ACC5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5718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4EC53-74DA-4F8B-8E5D-B272133704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363D88-4BE8-4259-B9FC-06192DDC5A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372DB3-65C4-476F-A4B5-6ED70F19C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0A5ED7-5926-42A5-919A-F8D6024D5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FCF74D-3103-4EF9-8092-F2A0E7BE9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0814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B41CF7-B931-4A26-B1FD-7A895EBDC4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D4D7F2-BEAD-4503-A1DB-34930117EC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C478E6-62EB-4B22-B25A-7EBE0A231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7FFC05-EF4A-4CDB-A71C-F7EF8FD73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9B3EF-3F0C-49AD-B56B-A5E65CBDA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5516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410D59-2F0A-44C0-AC4D-96B9B1B78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8A08B7-6E2E-4E0E-B108-B4B79704B6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04C3C0-C60A-4BFC-A4B2-EC6AC2E7D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8A565E-EC76-441E-85F2-0E3980960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0E8E07-76BA-413E-B073-1A729EB14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9681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30A1F-2FEC-499E-867F-39ED1C93B3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477FE6-CC89-4D56-87C3-0888252BD3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4C607-D6F5-4B09-93F3-4DDCB3C03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233A6B-869D-4BE6-AE44-56A0D5103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B8B588-97D3-40D6-ACB8-73C42FF2F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8439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C8792-622A-4C21-90FF-BFB12664F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1BFC09-8724-4FF9-B1DF-18D8756FA9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50AEEB-FBAB-4C52-8C81-6519A8665F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39B9CA-87CB-4541-9553-26727C13C5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35D34A-6D45-4805-A2A0-AF206A3EB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93DAF6-0AFB-4367-AC8E-E60953C22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680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5EEDA-990F-4DCD-88D8-3CF8CF2A7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B05B3F-1185-47CD-9159-2D1E3E8B4C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9D7B4C-DEC2-4298-9FCF-4EE691825A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5D9570-59D0-4002-A327-B15389CE96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F2EBA1-95EB-49A4-A830-956D31B4C4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E2FC7DB-9198-4958-9806-744FD13BC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5A9DE3-F791-4637-B2F6-871914C19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640DB68-BAB4-43E7-A2EA-17CC03B95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734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E584F-D381-4EDE-9569-7A58A76AC9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8C57AA0-2C99-4F95-8D9E-55C74E87D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365071-2214-4B5D-8915-462B2D2CD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34E824-3C2F-4EB8-B6A1-DCCE4B855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860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6A13FD-D547-44F6-92BE-628294F7E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51C373-890D-4102-8E03-A36C9F081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76119B-1678-425C-987E-9594C13DF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2297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642C3-DDD3-41BD-BE39-6F6E0D29D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38EA4A-2E38-4213-8670-53208B5692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423838-BDE7-4C8C-A961-9AC6FA179F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13C14E-D383-47DD-AE2D-E0223F2F8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5BB485-7DF1-412A-A34D-212322304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95B848-AB37-4F88-98E0-9ABE8C979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0870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66312-A84A-4926-BDDB-59A8AC5E8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081471-51C2-4FF5-AA38-371350938C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847DE9-1D78-49AE-8641-C624622AED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638705-7356-498A-850A-6FBF1111C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8DD438-C32C-4422-9769-10860FDAD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692FD3-972C-4F57-BC6E-C9F6F25F9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1219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9DAD2C-4515-495C-B458-0840341CA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7C7722-B708-4EC9-9F03-1325CB35E1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E56577-344B-4D01-9390-5BE941D407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7D06C-C263-4DB3-A90C-AABE151FDA48}" type="datetimeFigureOut">
              <a:rPr lang="en-GB" smtClean="0"/>
              <a:t>29/10/2018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E82126-9549-46B1-8FD9-A006458550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8AB2F-0CED-4D7E-8F26-0B714D669B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6CBE8-8979-4291-95B9-9A86F236F5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1036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3D8282BB-AE3F-4D77-B7BC-A823B99824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62501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A</a:t>
            </a:r>
            <a:endParaRPr lang="en-GB" altLang="en-US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22565"/>
            <a:ext cx="5525065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14105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7FA87748-0362-4883-A973-4657CA225A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831" y="225085"/>
            <a:ext cx="256480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J</a:t>
            </a:r>
            <a:endParaRPr lang="en-GB" alt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8792"/>
            <a:ext cx="5525065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56507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B939A583-9C9C-45D6-B9B0-94712B0B4D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61052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K</a:t>
            </a:r>
            <a:endParaRPr lang="en-GB" alt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999"/>
            <a:ext cx="5514600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6113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96B38346-CD90-4851-92CD-24825C0C0F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61372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B</a:t>
            </a:r>
            <a:endParaRPr lang="en-GB" altLang="en-US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656"/>
            <a:ext cx="5518227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53897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12">
            <a:extLst>
              <a:ext uri="{FF2B5EF4-FFF2-40B4-BE49-F238E27FC236}">
                <a16:creationId xmlns:a16="http://schemas.microsoft.com/office/drawing/2014/main" id="{D8692C37-466C-4EDC-A5A3-F0C4DFE6E3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6017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C</a:t>
            </a:r>
            <a:endParaRPr lang="en-GB" altLang="en-US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656"/>
            <a:ext cx="5518227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8124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4689E9B9-EE7D-4373-9DA4-02E9D67138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62975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D</a:t>
            </a:r>
            <a:endParaRPr lang="en-GB" altLang="en-US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999"/>
            <a:ext cx="5514600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92154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D528CE0F-F9DF-458A-8D78-FAE6FE1739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59609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E</a:t>
            </a:r>
            <a:endParaRPr lang="en-GB" altLang="en-US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515"/>
            <a:ext cx="5514600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44463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DC9E6897-0A3E-46ED-8D36-C6B2AF17DC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58968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F</a:t>
            </a:r>
            <a:endParaRPr lang="en-GB" altLang="en-US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656"/>
            <a:ext cx="5538741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12782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F57E99D6-F237-430F-9A91-C3B37524B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6273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G</a:t>
            </a:r>
            <a:endParaRPr lang="en-GB" alt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999"/>
            <a:ext cx="5514600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53710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DE40226D-56B0-407F-9E75-68A60C660C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62975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H</a:t>
            </a:r>
            <a:endParaRPr lang="en-GB" alt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19999"/>
            <a:ext cx="5514600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19160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12">
            <a:extLst>
              <a:ext uri="{FF2B5EF4-FFF2-40B4-BE49-F238E27FC236}">
                <a16:creationId xmlns:a16="http://schemas.microsoft.com/office/drawing/2014/main" id="{876EC498-00BF-4EED-8767-27CBF00978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628" y="225085"/>
            <a:ext cx="254479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itchFamily="34" charset="0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b="1" dirty="0"/>
              <a:t>Supplementary</a:t>
            </a:r>
            <a:r>
              <a:rPr lang="fr-FR" altLang="en-US" b="1" dirty="0"/>
              <a:t> figure 1.I</a:t>
            </a:r>
            <a:endParaRPr lang="en-GB" alt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000" y="1821600"/>
            <a:ext cx="5525065" cy="360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7898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4</TotalTime>
  <Words>415</Words>
  <Application>Microsoft Office PowerPoint</Application>
  <PresentationFormat>Widescreen</PresentationFormat>
  <Paragraphs>33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ra Isabel Mata</dc:creator>
  <cp:lastModifiedBy>Gillian Attard</cp:lastModifiedBy>
  <cp:revision>25</cp:revision>
  <dcterms:created xsi:type="dcterms:W3CDTF">2018-02-03T10:56:15Z</dcterms:created>
  <dcterms:modified xsi:type="dcterms:W3CDTF">2018-10-29T12:17:49Z</dcterms:modified>
</cp:coreProperties>
</file>